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EFF8ED-0B9D-46E3-85CC-CC1BA699B23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5EC751-37CE-45F4-AE65-A2226BCA7E7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10DA49-CE7D-447B-BFBB-834DD317459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F554F4-F214-4874-B86F-BD3BDA12E4C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D761E1-6453-4625-BCC7-84C6325922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975F8E-E3AF-4A06-8D7E-5D592A4E619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9133FE-18F7-44D3-9569-DCC1AFAEEA5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D70E18-3BA2-460C-93A3-A3CA07BD3B4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AED631-D531-4BA2-BD9D-2F73FF42514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0DA9E4-FECA-469F-942A-6B7B0590692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174A5C-E4BB-4F94-A5F8-CD6B48E2A5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F0EC94-47A2-4C4E-ABB8-A3289804DE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等线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等线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等线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等线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等线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等线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等线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等线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9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900" spc="-1" strike="noStrike">
                <a:solidFill>
                  <a:srgbClr val="898989"/>
                </a:solidFill>
                <a:latin typeface="Arial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9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894A56B-BBEB-40E2-AC00-D550D5B2FF13}" type="slidenum">
              <a:rPr b="0" lang="zh-CN" sz="9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图片 2" descr=""/>
          <p:cNvPicPr/>
          <p:nvPr/>
        </p:nvPicPr>
        <p:blipFill>
          <a:blip r:embed="rId1"/>
          <a:srcRect l="18983" t="19436" r="25039" b="29579"/>
          <a:stretch/>
        </p:blipFill>
        <p:spPr>
          <a:xfrm>
            <a:off x="2625840" y="1727280"/>
            <a:ext cx="2160360" cy="2622600"/>
          </a:xfrm>
          <a:prstGeom prst="rect">
            <a:avLst/>
          </a:prstGeom>
          <a:ln w="0">
            <a:noFill/>
          </a:ln>
        </p:spPr>
      </p:pic>
      <p:sp>
        <p:nvSpPr>
          <p:cNvPr id="42" name="矩形 8"/>
          <p:cNvSpPr/>
          <p:nvPr/>
        </p:nvSpPr>
        <p:spPr>
          <a:xfrm>
            <a:off x="1908000" y="4724280"/>
            <a:ext cx="554364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Figure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S1.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</a:rPr>
              <a:t> The right eye of the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OI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rat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</a:rPr>
              <a:t> showed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ptosis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symptoms similar to those of the proband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with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i="1" lang="en-US" sz="1600" spc="-1" strike="noStrike">
                <a:solidFill>
                  <a:srgbClr val="000000"/>
                </a:solidFill>
                <a:latin typeface="Times New Roman"/>
              </a:rPr>
              <a:t>WNT1</a:t>
            </a:r>
            <a:r>
              <a:rPr b="0" i="1" lang="zh-CN" sz="16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mutation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76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1999-03-26T11:39:20Z</dcterms:created>
  <dc:creator>HE Wei</dc:creator>
  <dc:description/>
  <dc:language>en-US</dc:language>
  <cp:lastModifiedBy>Microsoft 帐户</cp:lastModifiedBy>
  <dcterms:modified xsi:type="dcterms:W3CDTF">2024-12-10T02:15:09Z</dcterms:modified>
  <cp:revision>1257</cp:revision>
  <dc:subject/>
  <dc:title>Introduction of immune system</dc:title>
</cp:coreProperties>
</file>